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4" d="100"/>
          <a:sy n="124" d="100"/>
        </p:scale>
        <p:origin x="12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AED93-B150-4925-83C3-32C120DAD947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877FA-20E9-4F7E-A77D-D2F04C6F69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8932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AED93-B150-4925-83C3-32C120DAD947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877FA-20E9-4F7E-A77D-D2F04C6F69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79041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AED93-B150-4925-83C3-32C120DAD947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877FA-20E9-4F7E-A77D-D2F04C6F69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71970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AED93-B150-4925-83C3-32C120DAD947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877FA-20E9-4F7E-A77D-D2F04C6F69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5447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AED93-B150-4925-83C3-32C120DAD947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877FA-20E9-4F7E-A77D-D2F04C6F69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2772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AED93-B150-4925-83C3-32C120DAD947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877FA-20E9-4F7E-A77D-D2F04C6F69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16300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AED93-B150-4925-83C3-32C120DAD947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877FA-20E9-4F7E-A77D-D2F04C6F69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0307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AED93-B150-4925-83C3-32C120DAD947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877FA-20E9-4F7E-A77D-D2F04C6F69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9819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AED93-B150-4925-83C3-32C120DAD947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877FA-20E9-4F7E-A77D-D2F04C6F69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4038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AED93-B150-4925-83C3-32C120DAD947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877FA-20E9-4F7E-A77D-D2F04C6F69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62260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AED93-B150-4925-83C3-32C120DAD947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7877FA-20E9-4F7E-A77D-D2F04C6F69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98862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EAED93-B150-4925-83C3-32C120DAD947}" type="datetimeFigureOut">
              <a:rPr lang="de-DE" smtClean="0"/>
              <a:t>16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7877FA-20E9-4F7E-A77D-D2F04C6F69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504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10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tiff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7" Type="http://schemas.openxmlformats.org/officeDocument/2006/relationships/image" Target="../media/image1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openxmlformats.org/officeDocument/2006/relationships/image" Target="../media/image11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7" Type="http://schemas.openxmlformats.org/officeDocument/2006/relationships/image" Target="../media/image18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3254501" y="92919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0" lang="de-DE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00" t="33165" r="22590" b="59627"/>
          <a:stretch/>
        </p:blipFill>
        <p:spPr>
          <a:xfrm>
            <a:off x="3855339" y="1792293"/>
            <a:ext cx="1058400" cy="1311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feld 5"/>
          <p:cNvSpPr txBox="1"/>
          <p:nvPr/>
        </p:nvSpPr>
        <p:spPr>
          <a:xfrm>
            <a:off x="5000863" y="1762395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3666217" y="178191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Tabel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6424566"/>
              </p:ext>
            </p:extLst>
          </p:nvPr>
        </p:nvGraphicFramePr>
        <p:xfrm>
          <a:off x="3851011" y="1511694"/>
          <a:ext cx="1067056" cy="28012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3382">
                  <a:extLst>
                    <a:ext uri="{9D8B030D-6E8A-4147-A177-3AD203B41FA5}">
                      <a16:colId xmlns:a16="http://schemas.microsoft.com/office/drawing/2014/main" val="2449043452"/>
                    </a:ext>
                  </a:extLst>
                </a:gridCol>
                <a:gridCol w="133382">
                  <a:extLst>
                    <a:ext uri="{9D8B030D-6E8A-4147-A177-3AD203B41FA5}">
                      <a16:colId xmlns:a16="http://schemas.microsoft.com/office/drawing/2014/main" val="659089396"/>
                    </a:ext>
                  </a:extLst>
                </a:gridCol>
                <a:gridCol w="133382">
                  <a:extLst>
                    <a:ext uri="{9D8B030D-6E8A-4147-A177-3AD203B41FA5}">
                      <a16:colId xmlns:a16="http://schemas.microsoft.com/office/drawing/2014/main" val="710766068"/>
                    </a:ext>
                  </a:extLst>
                </a:gridCol>
                <a:gridCol w="133382">
                  <a:extLst>
                    <a:ext uri="{9D8B030D-6E8A-4147-A177-3AD203B41FA5}">
                      <a16:colId xmlns:a16="http://schemas.microsoft.com/office/drawing/2014/main" val="3660094485"/>
                    </a:ext>
                  </a:extLst>
                </a:gridCol>
                <a:gridCol w="133382">
                  <a:extLst>
                    <a:ext uri="{9D8B030D-6E8A-4147-A177-3AD203B41FA5}">
                      <a16:colId xmlns:a16="http://schemas.microsoft.com/office/drawing/2014/main" val="1411193577"/>
                    </a:ext>
                  </a:extLst>
                </a:gridCol>
                <a:gridCol w="133382">
                  <a:extLst>
                    <a:ext uri="{9D8B030D-6E8A-4147-A177-3AD203B41FA5}">
                      <a16:colId xmlns:a16="http://schemas.microsoft.com/office/drawing/2014/main" val="1368244219"/>
                    </a:ext>
                  </a:extLst>
                </a:gridCol>
                <a:gridCol w="133382">
                  <a:extLst>
                    <a:ext uri="{9D8B030D-6E8A-4147-A177-3AD203B41FA5}">
                      <a16:colId xmlns:a16="http://schemas.microsoft.com/office/drawing/2014/main" val="2788039296"/>
                    </a:ext>
                  </a:extLst>
                </a:gridCol>
                <a:gridCol w="133382">
                  <a:extLst>
                    <a:ext uri="{9D8B030D-6E8A-4147-A177-3AD203B41FA5}">
                      <a16:colId xmlns:a16="http://schemas.microsoft.com/office/drawing/2014/main" val="1364247529"/>
                    </a:ext>
                  </a:extLst>
                </a:gridCol>
              </a:tblGrid>
              <a:tr h="93376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330235"/>
                  </a:ext>
                </a:extLst>
              </a:tr>
              <a:tr h="93376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8339950"/>
                  </a:ext>
                </a:extLst>
              </a:tr>
              <a:tr h="93376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929146"/>
                  </a:ext>
                </a:extLst>
              </a:tr>
            </a:tbl>
          </a:graphicData>
        </a:graphic>
      </p:graphicFrame>
      <p:sp>
        <p:nvSpPr>
          <p:cNvPr id="9" name="Textfeld 8"/>
          <p:cNvSpPr txBox="1"/>
          <p:nvPr/>
        </p:nvSpPr>
        <p:spPr>
          <a:xfrm>
            <a:off x="4847626" y="1659656"/>
            <a:ext cx="9749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/ml CD95L [min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4847626" y="1558573"/>
            <a:ext cx="7120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 µM BV6 [min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4847626" y="1461771"/>
            <a:ext cx="9557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 µM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VAD-fmk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[min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5003057" y="2133662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3660603" y="215685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02" t="30351" r="24690" b="63828"/>
          <a:stretch/>
        </p:blipFill>
        <p:spPr>
          <a:xfrm>
            <a:off x="3855339" y="1936127"/>
            <a:ext cx="1058400" cy="1058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feld 14"/>
          <p:cNvSpPr txBox="1"/>
          <p:nvPr/>
        </p:nvSpPr>
        <p:spPr>
          <a:xfrm>
            <a:off x="5000863" y="1893901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3666217" y="188412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5002723" y="2250631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660603" y="223919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91" t="36329" r="17999" b="56989"/>
          <a:stretch/>
        </p:blipFill>
        <p:spPr>
          <a:xfrm>
            <a:off x="3855339" y="2036199"/>
            <a:ext cx="1058400" cy="1215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Textfeld 19"/>
          <p:cNvSpPr txBox="1"/>
          <p:nvPr/>
        </p:nvSpPr>
        <p:spPr>
          <a:xfrm>
            <a:off x="5000863" y="2012449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3666217" y="19953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4149860" y="1286677"/>
            <a:ext cx="4539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Jurkat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Gerade Verbindung mit Pfeil 22"/>
          <p:cNvCxnSpPr/>
          <p:nvPr/>
        </p:nvCxnSpPr>
        <p:spPr>
          <a:xfrm flipH="1">
            <a:off x="4926825" y="186557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feld 23"/>
          <p:cNvSpPr txBox="1"/>
          <p:nvPr/>
        </p:nvSpPr>
        <p:spPr>
          <a:xfrm>
            <a:off x="3472486" y="1652568"/>
            <a:ext cx="4491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 [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Gerade Verbindung mit Pfeil 24"/>
          <p:cNvCxnSpPr/>
          <p:nvPr/>
        </p:nvCxnSpPr>
        <p:spPr>
          <a:xfrm flipH="1">
            <a:off x="4929019" y="224449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mit Pfeil 25"/>
          <p:cNvCxnSpPr/>
          <p:nvPr/>
        </p:nvCxnSpPr>
        <p:spPr>
          <a:xfrm flipH="1">
            <a:off x="4926825" y="198263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mit Pfeil 26"/>
          <p:cNvCxnSpPr/>
          <p:nvPr/>
        </p:nvCxnSpPr>
        <p:spPr>
          <a:xfrm flipH="1">
            <a:off x="4928685" y="233297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mit Pfeil 27"/>
          <p:cNvCxnSpPr/>
          <p:nvPr/>
        </p:nvCxnSpPr>
        <p:spPr>
          <a:xfrm flipH="1">
            <a:off x="4926825" y="210604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9" name="Grafik 2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27" t="38872" r="33331" b="57619"/>
          <a:stretch/>
        </p:blipFill>
        <p:spPr>
          <a:xfrm>
            <a:off x="3855339" y="2216006"/>
            <a:ext cx="1058400" cy="663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Grafik 2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83" t="36841" r="30576" b="58542"/>
          <a:stretch/>
        </p:blipFill>
        <p:spPr>
          <a:xfrm>
            <a:off x="3855339" y="2289740"/>
            <a:ext cx="1058400" cy="873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Grafik 3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50" t="34070" r="28509" b="61497"/>
          <a:stretch/>
        </p:blipFill>
        <p:spPr>
          <a:xfrm>
            <a:off x="3857674" y="2380731"/>
            <a:ext cx="1058400" cy="8383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Textfeld 31"/>
          <p:cNvSpPr txBox="1"/>
          <p:nvPr/>
        </p:nvSpPr>
        <p:spPr>
          <a:xfrm>
            <a:off x="5000863" y="2332313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3661668" y="232889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Gerade Verbindung mit Pfeil 33"/>
          <p:cNvCxnSpPr/>
          <p:nvPr/>
        </p:nvCxnSpPr>
        <p:spPr>
          <a:xfrm flipH="1">
            <a:off x="4926825" y="242590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623943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00" t="33165" r="22590" b="59627"/>
          <a:stretch/>
        </p:blipFill>
        <p:spPr>
          <a:xfrm>
            <a:off x="668108" y="324643"/>
            <a:ext cx="1058400" cy="1311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feld 3"/>
          <p:cNvSpPr txBox="1"/>
          <p:nvPr/>
        </p:nvSpPr>
        <p:spPr>
          <a:xfrm>
            <a:off x="1813632" y="294745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478986" y="31426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02" t="30351" r="24690" b="63828"/>
          <a:stretch/>
        </p:blipFill>
        <p:spPr>
          <a:xfrm>
            <a:off x="6262084" y="337000"/>
            <a:ext cx="1058400" cy="1058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feld 12"/>
          <p:cNvSpPr txBox="1"/>
          <p:nvPr/>
        </p:nvSpPr>
        <p:spPr>
          <a:xfrm>
            <a:off x="7407608" y="294774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6072962" y="28499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Gerade Verbindung mit Pfeil 20"/>
          <p:cNvCxnSpPr/>
          <p:nvPr/>
        </p:nvCxnSpPr>
        <p:spPr>
          <a:xfrm flipH="1">
            <a:off x="1739594" y="39792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23"/>
          <p:cNvCxnSpPr/>
          <p:nvPr/>
        </p:nvCxnSpPr>
        <p:spPr>
          <a:xfrm flipH="1">
            <a:off x="7333570" y="38350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3" name="Grafik 3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06" r="16662" b="16433"/>
          <a:stretch/>
        </p:blipFill>
        <p:spPr>
          <a:xfrm>
            <a:off x="384200" y="3331309"/>
            <a:ext cx="3872753" cy="3476833"/>
          </a:xfrm>
          <a:prstGeom prst="rect">
            <a:avLst/>
          </a:prstGeom>
        </p:spPr>
      </p:pic>
      <p:pic>
        <p:nvPicPr>
          <p:cNvPr id="34" name="Grafik 3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58" t="15970" r="16111" b="16803"/>
          <a:stretch/>
        </p:blipFill>
        <p:spPr>
          <a:xfrm>
            <a:off x="614600" y="466122"/>
            <a:ext cx="3119717" cy="2796988"/>
          </a:xfrm>
          <a:prstGeom prst="rect">
            <a:avLst/>
          </a:prstGeom>
        </p:spPr>
      </p:pic>
      <p:pic>
        <p:nvPicPr>
          <p:cNvPr id="35" name="Grafik 3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142" b="23636"/>
          <a:stretch/>
        </p:blipFill>
        <p:spPr>
          <a:xfrm>
            <a:off x="4536212" y="3630986"/>
            <a:ext cx="4510144" cy="3177156"/>
          </a:xfrm>
          <a:prstGeom prst="rect">
            <a:avLst/>
          </a:prstGeom>
        </p:spPr>
      </p:pic>
      <p:pic>
        <p:nvPicPr>
          <p:cNvPr id="36" name="Grafik 3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41" t="16525" r="17075" b="16063"/>
          <a:stretch/>
        </p:blipFill>
        <p:spPr>
          <a:xfrm>
            <a:off x="4979254" y="531447"/>
            <a:ext cx="3211926" cy="2804672"/>
          </a:xfrm>
          <a:prstGeom prst="rect">
            <a:avLst/>
          </a:prstGeom>
        </p:spPr>
      </p:pic>
      <p:sp>
        <p:nvSpPr>
          <p:cNvPr id="37" name="Rechteck 36"/>
          <p:cNvSpPr/>
          <p:nvPr/>
        </p:nvSpPr>
        <p:spPr>
          <a:xfrm>
            <a:off x="445047" y="371163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496253" y="44889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496253" y="457633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496253" y="46676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496253" y="476835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496253" y="49535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496253" y="51659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496253" y="56454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496253" y="593678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496253" y="61467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496253" y="63944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496253" y="432888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1186738" y="425659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0" name="Rechteck 49"/>
          <p:cNvSpPr/>
          <p:nvPr/>
        </p:nvSpPr>
        <p:spPr>
          <a:xfrm>
            <a:off x="840549" y="1236983"/>
            <a:ext cx="2634961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1" name="Rechteck 50"/>
          <p:cNvSpPr/>
          <p:nvPr/>
        </p:nvSpPr>
        <p:spPr>
          <a:xfrm>
            <a:off x="5238856" y="3788479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5290062" y="456575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5290062" y="465317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5290062" y="47445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5" name="Rechteck 54"/>
          <p:cNvSpPr/>
          <p:nvPr/>
        </p:nvSpPr>
        <p:spPr>
          <a:xfrm>
            <a:off x="5290062" y="48452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5290062" y="503036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5290062" y="52427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8" name="Rechteck 57"/>
          <p:cNvSpPr/>
          <p:nvPr/>
        </p:nvSpPr>
        <p:spPr>
          <a:xfrm>
            <a:off x="5290062" y="572224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5290062" y="601362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5290062" y="622360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1" name="Rechteck 60"/>
          <p:cNvSpPr/>
          <p:nvPr/>
        </p:nvSpPr>
        <p:spPr>
          <a:xfrm>
            <a:off x="5290062" y="647133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2" name="Rechteck 61"/>
          <p:cNvSpPr/>
          <p:nvPr/>
        </p:nvSpPr>
        <p:spPr>
          <a:xfrm>
            <a:off x="5290062" y="440572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5980547" y="4333435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64" name="Rechteck 63"/>
          <p:cNvSpPr/>
          <p:nvPr/>
        </p:nvSpPr>
        <p:spPr>
          <a:xfrm>
            <a:off x="5290062" y="1113690"/>
            <a:ext cx="2634961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07317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7692469" y="264763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6350015" y="28795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91" t="36329" r="17999" b="56989"/>
          <a:stretch/>
        </p:blipFill>
        <p:spPr>
          <a:xfrm>
            <a:off x="770700" y="291923"/>
            <a:ext cx="1058400" cy="1215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feld 6"/>
          <p:cNvSpPr txBox="1"/>
          <p:nvPr/>
        </p:nvSpPr>
        <p:spPr>
          <a:xfrm>
            <a:off x="1916224" y="268173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581578" y="25111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Gerade Verbindung mit Pfeil 8"/>
          <p:cNvCxnSpPr/>
          <p:nvPr/>
        </p:nvCxnSpPr>
        <p:spPr>
          <a:xfrm flipH="1">
            <a:off x="7618431" y="37560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 Verbindung mit Pfeil 10"/>
          <p:cNvCxnSpPr/>
          <p:nvPr/>
        </p:nvCxnSpPr>
        <p:spPr>
          <a:xfrm flipH="1">
            <a:off x="1842186" y="36176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27" t="38872" r="33331" b="57619"/>
          <a:stretch/>
        </p:blipFill>
        <p:spPr>
          <a:xfrm>
            <a:off x="6544751" y="347107"/>
            <a:ext cx="1058400" cy="663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Grafik 1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66" r="12805" b="23451"/>
          <a:stretch/>
        </p:blipFill>
        <p:spPr>
          <a:xfrm>
            <a:off x="261258" y="3408061"/>
            <a:ext cx="4157062" cy="3184840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62" t="15047" r="13907" b="23820"/>
          <a:stretch/>
        </p:blipFill>
        <p:spPr>
          <a:xfrm>
            <a:off x="354335" y="546430"/>
            <a:ext cx="3119718" cy="2543415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49" t="12462" r="26581" b="20864"/>
          <a:stretch/>
        </p:blipFill>
        <p:spPr>
          <a:xfrm>
            <a:off x="5479514" y="543283"/>
            <a:ext cx="3188874" cy="2773936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821" b="21788"/>
          <a:stretch/>
        </p:blipFill>
        <p:spPr>
          <a:xfrm>
            <a:off x="4856693" y="3484902"/>
            <a:ext cx="4026049" cy="3253996"/>
          </a:xfrm>
          <a:prstGeom prst="rect">
            <a:avLst/>
          </a:prstGeom>
        </p:spPr>
      </p:pic>
      <p:sp>
        <p:nvSpPr>
          <p:cNvPr id="23" name="Rechteck 22"/>
          <p:cNvSpPr/>
          <p:nvPr/>
        </p:nvSpPr>
        <p:spPr>
          <a:xfrm>
            <a:off x="581578" y="355795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632784" y="433523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632784" y="442265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632784" y="451401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632784" y="461467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632784" y="47998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632784" y="50122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632784" y="54917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632784" y="57831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632784" y="59930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632784" y="62408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632784" y="417520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1323269" y="410291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6" name="Rechteck 35"/>
          <p:cNvSpPr/>
          <p:nvPr/>
        </p:nvSpPr>
        <p:spPr>
          <a:xfrm>
            <a:off x="668721" y="1462660"/>
            <a:ext cx="2634961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7" name="Rechteck 36"/>
          <p:cNvSpPr/>
          <p:nvPr/>
        </p:nvSpPr>
        <p:spPr>
          <a:xfrm>
            <a:off x="5108805" y="381956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5160011" y="459684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5160011" y="46842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5160011" y="47756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5160011" y="487628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5160011" y="506145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5160011" y="52738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5160011" y="575333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5160011" y="604471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5160011" y="62546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5160011" y="650242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5160011" y="44368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5850496" y="436452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0" name="Rechteck 49"/>
          <p:cNvSpPr/>
          <p:nvPr/>
        </p:nvSpPr>
        <p:spPr>
          <a:xfrm>
            <a:off x="5850496" y="1612465"/>
            <a:ext cx="2634961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62051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082791" y="437199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740671" y="42576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Gerade Verbindung mit Pfeil 3"/>
          <p:cNvCxnSpPr/>
          <p:nvPr/>
        </p:nvCxnSpPr>
        <p:spPr>
          <a:xfrm flipH="1">
            <a:off x="2008753" y="51953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83" t="36841" r="30576" b="58542"/>
          <a:stretch/>
        </p:blipFill>
        <p:spPr>
          <a:xfrm>
            <a:off x="935407" y="476308"/>
            <a:ext cx="1058400" cy="873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50" t="34070" r="28509" b="61497"/>
          <a:stretch/>
        </p:blipFill>
        <p:spPr>
          <a:xfrm>
            <a:off x="6477930" y="476308"/>
            <a:ext cx="1058400" cy="8383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feld 6"/>
          <p:cNvSpPr txBox="1"/>
          <p:nvPr/>
        </p:nvSpPr>
        <p:spPr>
          <a:xfrm>
            <a:off x="7621119" y="427890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6281924" y="42447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Gerade Verbindung mit Pfeil 8"/>
          <p:cNvCxnSpPr/>
          <p:nvPr/>
        </p:nvCxnSpPr>
        <p:spPr>
          <a:xfrm flipH="1">
            <a:off x="7547081" y="52148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239" b="21788"/>
          <a:stretch/>
        </p:blipFill>
        <p:spPr>
          <a:xfrm>
            <a:off x="345781" y="3431113"/>
            <a:ext cx="4225834" cy="3253996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68" t="15418" r="23689" b="27698"/>
          <a:stretch/>
        </p:blipFill>
        <p:spPr>
          <a:xfrm>
            <a:off x="345781" y="672411"/>
            <a:ext cx="3142769" cy="2366682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95" t="11169" r="19555" b="24374"/>
          <a:stretch/>
        </p:blipFill>
        <p:spPr>
          <a:xfrm>
            <a:off x="5532505" y="749385"/>
            <a:ext cx="3327186" cy="2681728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586" b="30099"/>
          <a:stretch/>
        </p:blipFill>
        <p:spPr>
          <a:xfrm>
            <a:off x="4825957" y="3750058"/>
            <a:ext cx="4318043" cy="2908215"/>
          </a:xfrm>
          <a:prstGeom prst="rect">
            <a:avLst/>
          </a:prstGeom>
        </p:spPr>
      </p:pic>
      <p:sp>
        <p:nvSpPr>
          <p:cNvPr id="14" name="Rechteck 13"/>
          <p:cNvSpPr/>
          <p:nvPr/>
        </p:nvSpPr>
        <p:spPr>
          <a:xfrm>
            <a:off x="756039" y="371163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15" name="Rechteck 14"/>
          <p:cNvSpPr/>
          <p:nvPr/>
        </p:nvSpPr>
        <p:spPr>
          <a:xfrm>
            <a:off x="807245" y="44889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6" name="Rechteck 15"/>
          <p:cNvSpPr/>
          <p:nvPr/>
        </p:nvSpPr>
        <p:spPr>
          <a:xfrm>
            <a:off x="807245" y="457633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7" name="Rechteck 16"/>
          <p:cNvSpPr/>
          <p:nvPr/>
        </p:nvSpPr>
        <p:spPr>
          <a:xfrm>
            <a:off x="807245" y="466769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807245" y="476835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807245" y="49535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0" name="Rechteck 19"/>
          <p:cNvSpPr/>
          <p:nvPr/>
        </p:nvSpPr>
        <p:spPr>
          <a:xfrm>
            <a:off x="807245" y="51659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807245" y="56454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807245" y="593678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807245" y="61467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807245" y="63944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807245" y="432888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1497730" y="425659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27" name="Rechteck 26"/>
          <p:cNvSpPr/>
          <p:nvPr/>
        </p:nvSpPr>
        <p:spPr>
          <a:xfrm>
            <a:off x="676326" y="1538125"/>
            <a:ext cx="2634961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8" name="Rechteck 27"/>
          <p:cNvSpPr/>
          <p:nvPr/>
        </p:nvSpPr>
        <p:spPr>
          <a:xfrm>
            <a:off x="5322270" y="375005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5373476" y="452733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5373476" y="461475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5373476" y="470611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5373476" y="480677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5373476" y="49919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5373476" y="52043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5373476" y="56838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5373476" y="59752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5373476" y="61851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5373476" y="64329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5373476" y="436730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6063961" y="429501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1" name="Rechteck 40"/>
          <p:cNvSpPr/>
          <p:nvPr/>
        </p:nvSpPr>
        <p:spPr>
          <a:xfrm>
            <a:off x="5878617" y="1731202"/>
            <a:ext cx="2634961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13136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98</Words>
  <Application>Microsoft Office PowerPoint</Application>
  <PresentationFormat>Bildschirmpräsentation (4:3)</PresentationFormat>
  <Paragraphs>132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2</cp:revision>
  <dcterms:created xsi:type="dcterms:W3CDTF">2024-08-16T14:32:53Z</dcterms:created>
  <dcterms:modified xsi:type="dcterms:W3CDTF">2024-08-16T14:44:19Z</dcterms:modified>
</cp:coreProperties>
</file>